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9"/>
  </p:notesMasterIdLst>
  <p:sldIdLst>
    <p:sldId id="256" r:id="rId2"/>
    <p:sldId id="269" r:id="rId3"/>
    <p:sldId id="262" r:id="rId4"/>
    <p:sldId id="257" r:id="rId5"/>
    <p:sldId id="277" r:id="rId6"/>
    <p:sldId id="263" r:id="rId7"/>
    <p:sldId id="278" r:id="rId8"/>
    <p:sldId id="272" r:id="rId9"/>
    <p:sldId id="273" r:id="rId10"/>
    <p:sldId id="274" r:id="rId11"/>
    <p:sldId id="260" r:id="rId12"/>
    <p:sldId id="261" r:id="rId13"/>
    <p:sldId id="264" r:id="rId14"/>
    <p:sldId id="265" r:id="rId15"/>
    <p:sldId id="266" r:id="rId16"/>
    <p:sldId id="275" r:id="rId17"/>
    <p:sldId id="279" r:id="rId1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BD5F"/>
    <a:srgbClr val="005EA4"/>
    <a:srgbClr val="97C777"/>
    <a:srgbClr val="DE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23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6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B507CE-DBCF-4E9B-8EE1-8EF0BCEF3893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39C0F9-D23B-42E4-8055-799753B932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3581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DFCB5D-D72A-0A4C-90F7-A0384F562275}" type="slidenum">
              <a:rPr kumimoji="1" lang="zh-CN" altLang="en-US" smtClean="0"/>
              <a:t>10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30421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39C0F9-D23B-42E4-8055-799753B93225}" type="slidenum">
              <a:rPr lang="zh-CN" altLang="en-US" smtClean="0"/>
              <a:t>1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45549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728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645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6468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0835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9124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199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1439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2949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0944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921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5466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045A0-EAC9-4117-9AA0-0B43D035A828}" type="datetimeFigureOut">
              <a:rPr lang="zh-CN" altLang="en-US" smtClean="0"/>
              <a:t>2025/4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9DE3B-ECAD-4D45-BE8C-07CAC32B6F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787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jpeg"/><Relationship Id="rId5" Type="http://schemas.openxmlformats.org/officeDocument/2006/relationships/image" Target="../media/image48.png"/><Relationship Id="rId4" Type="http://schemas.openxmlformats.org/officeDocument/2006/relationships/image" Target="../media/image47.jpe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3" Type="http://schemas.openxmlformats.org/officeDocument/2006/relationships/image" Target="../media/image8.png"/><Relationship Id="rId21" Type="http://schemas.openxmlformats.org/officeDocument/2006/relationships/image" Target="../media/image26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5" Type="http://schemas.openxmlformats.org/officeDocument/2006/relationships/image" Target="../media/image30.png"/><Relationship Id="rId2" Type="http://schemas.openxmlformats.org/officeDocument/2006/relationships/image" Target="../media/image7.png"/><Relationship Id="rId16" Type="http://schemas.openxmlformats.org/officeDocument/2006/relationships/image" Target="../media/image21.png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24" Type="http://schemas.openxmlformats.org/officeDocument/2006/relationships/image" Target="../media/image29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23" Type="http://schemas.openxmlformats.org/officeDocument/2006/relationships/image" Target="../media/image28.png"/><Relationship Id="rId10" Type="http://schemas.openxmlformats.org/officeDocument/2006/relationships/image" Target="../media/image15.png"/><Relationship Id="rId19" Type="http://schemas.openxmlformats.org/officeDocument/2006/relationships/image" Target="../media/image24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Relationship Id="rId22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>
            <a:extLst>
              <a:ext uri="{FF2B5EF4-FFF2-40B4-BE49-F238E27FC236}">
                <a16:creationId xmlns:a16="http://schemas.microsoft.com/office/drawing/2014/main" id="{871515E1-EF25-3E0D-262C-26ED8EB2DD2C}"/>
              </a:ext>
            </a:extLst>
          </p:cNvPr>
          <p:cNvGrpSpPr/>
          <p:nvPr/>
        </p:nvGrpSpPr>
        <p:grpSpPr>
          <a:xfrm>
            <a:off x="16542" y="58445"/>
            <a:ext cx="9114278" cy="4149988"/>
            <a:chOff x="16542" y="98200"/>
            <a:chExt cx="9114278" cy="4149988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C9C9010C-ABD8-04E3-0013-BAC778AD0D5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5838" y="98200"/>
              <a:ext cx="6224982" cy="4149988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BFD13F9-EB27-656E-11B6-D2EC956091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542" y="98201"/>
              <a:ext cx="3653218" cy="4149987"/>
            </a:xfrm>
            <a:prstGeom prst="rect">
              <a:avLst/>
            </a:prstGeom>
          </p:spPr>
        </p:pic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8E29F141-D1D6-BC60-4DEB-17E4661B7227}"/>
              </a:ext>
            </a:extLst>
          </p:cNvPr>
          <p:cNvSpPr txBox="1"/>
          <p:nvPr/>
        </p:nvSpPr>
        <p:spPr>
          <a:xfrm>
            <a:off x="271586" y="3717768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endParaRPr kumimoji="1"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B3AF193-9231-1A5D-2D60-32F951D00833}"/>
              </a:ext>
            </a:extLst>
          </p:cNvPr>
          <p:cNvSpPr txBox="1"/>
          <p:nvPr/>
        </p:nvSpPr>
        <p:spPr>
          <a:xfrm>
            <a:off x="2779461" y="371776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71</a:t>
            </a:r>
            <a:endParaRPr kumimoji="1"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4">
            <a:extLst>
              <a:ext uri="{FF2B5EF4-FFF2-40B4-BE49-F238E27FC236}">
                <a16:creationId xmlns:a16="http://schemas.microsoft.com/office/drawing/2014/main" id="{28F6776C-7022-4CBF-8D74-46F61AA330C2}"/>
              </a:ext>
            </a:extLst>
          </p:cNvPr>
          <p:cNvPicPr/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1847905" y="4414801"/>
            <a:ext cx="3314147" cy="1915729"/>
          </a:xfrm>
          <a:prstGeom prst="rect">
            <a:avLst/>
          </a:prstGeom>
          <a:noFill/>
          <a:ln>
            <a:noFill/>
          </a:ln>
          <a:effectLst/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36E0CC1-B9F5-47AE-91F1-A70198134F22}"/>
              </a:ext>
            </a:extLst>
          </p:cNvPr>
          <p:cNvPicPr/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94345" y="4414801"/>
            <a:ext cx="1929361" cy="191572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E29F141-D1D6-BC60-4DEB-17E4661B7227}"/>
              </a:ext>
            </a:extLst>
          </p:cNvPr>
          <p:cNvSpPr txBox="1"/>
          <p:nvPr/>
        </p:nvSpPr>
        <p:spPr>
          <a:xfrm>
            <a:off x="4708082" y="3580923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endParaRPr kumimoji="1"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E29F141-D1D6-BC60-4DEB-17E4661B7227}"/>
              </a:ext>
            </a:extLst>
          </p:cNvPr>
          <p:cNvSpPr txBox="1"/>
          <p:nvPr/>
        </p:nvSpPr>
        <p:spPr>
          <a:xfrm>
            <a:off x="2412419" y="5196140"/>
            <a:ext cx="569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E29F141-D1D6-BC60-4DEB-17E4661B7227}"/>
              </a:ext>
            </a:extLst>
          </p:cNvPr>
          <p:cNvSpPr txBox="1"/>
          <p:nvPr/>
        </p:nvSpPr>
        <p:spPr>
          <a:xfrm>
            <a:off x="5643974" y="6021795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endParaRPr kumimoji="1"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B3AF193-9231-1A5D-2D60-32F951D00833}"/>
              </a:ext>
            </a:extLst>
          </p:cNvPr>
          <p:cNvSpPr txBox="1"/>
          <p:nvPr/>
        </p:nvSpPr>
        <p:spPr>
          <a:xfrm>
            <a:off x="6806996" y="6051613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71</a:t>
            </a:r>
            <a:endParaRPr kumimoji="1"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B3AF193-9231-1A5D-2D60-32F951D00833}"/>
              </a:ext>
            </a:extLst>
          </p:cNvPr>
          <p:cNvSpPr txBox="1"/>
          <p:nvPr/>
        </p:nvSpPr>
        <p:spPr>
          <a:xfrm>
            <a:off x="3866851" y="5172890"/>
            <a:ext cx="938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71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B3AF193-9231-1A5D-2D60-32F951D00833}"/>
              </a:ext>
            </a:extLst>
          </p:cNvPr>
          <p:cNvSpPr txBox="1"/>
          <p:nvPr/>
        </p:nvSpPr>
        <p:spPr>
          <a:xfrm>
            <a:off x="7423706" y="364255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71</a:t>
            </a:r>
            <a:endParaRPr kumimoji="1"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82934" y="193963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500263" y="193963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427514" y="4230135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078708" y="4230135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813A68E6-8141-CEC2-02BC-24C27430DE54}"/>
              </a:ext>
            </a:extLst>
          </p:cNvPr>
          <p:cNvSpPr/>
          <p:nvPr/>
        </p:nvSpPr>
        <p:spPr>
          <a:xfrm>
            <a:off x="3580120" y="3939890"/>
            <a:ext cx="18000" cy="144000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02744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48931DB-49A9-2A33-7CF8-CDC87184BA98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6025" y="463079"/>
            <a:ext cx="8736278" cy="4292946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26431" y="93747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A719A97-6FE5-0413-F7FB-A1AE87712ED4}"/>
              </a:ext>
            </a:extLst>
          </p:cNvPr>
          <p:cNvSpPr txBox="1"/>
          <p:nvPr/>
        </p:nvSpPr>
        <p:spPr>
          <a:xfrm>
            <a:off x="403270" y="5042118"/>
            <a:ext cx="8481787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.  Variants in the gene body of </a:t>
            </a:r>
            <a:r>
              <a:rPr kumimoji="1"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e 22 copies in SP.</a:t>
            </a:r>
            <a:endParaRPr kumimoji="1" lang="en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DNA alignment of </a:t>
            </a:r>
            <a:r>
              <a:rPr kumimoji="1" lang="en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1s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the gene body in SP. The 1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2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4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8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6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21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pies contain variants (marked in red-line boxes) inducing a gene-frame shift or an early stoppage in translation. The 3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5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6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7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1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2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8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19</a:t>
            </a:r>
            <a:r>
              <a:rPr kumimoji="1" lang="en-US" altLang="zh-CN" sz="16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pies are truncated.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lack-line box signifies intron. The start and stop codons are displayed in green boxes. (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otein alignment of 14 </a:t>
            </a:r>
            <a:r>
              <a:rPr kumimoji="1"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1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ies with full CDS in SP.</a:t>
            </a:r>
          </a:p>
          <a:p>
            <a:endParaRPr kumimoji="1" lang="en-US" altLang="zh-CN" sz="16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68392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D4A9FB5-7D54-F391-15CF-FAC6F8D7173A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61" y="1257809"/>
            <a:ext cx="9119439" cy="4301179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30629" y="888477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59287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8A12A08-A27B-7DFF-ED7C-180EEB8DDE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202" y="200738"/>
            <a:ext cx="8994358" cy="517916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61364" y="5300014"/>
            <a:ext cx="845651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.  Comparisons of the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Ss between SP and MS71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S71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m00035ab01497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ains a 1-bp insertion and a 1-bp deletion (without color) in the CDS, resulting in a gene-frame shift. Additionally, other unhighlighted sequences without color indicate deletions with lengths that are exact multiples of three. (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otein alignment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SP and MS7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61364" y="0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37070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10FD8E4-0C91-0627-BA0C-76E0166E85B8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333350"/>
            <a:ext cx="9043638" cy="612920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30521" y="0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134145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132BBAE-A512-F52E-4517-B9E484C59A54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3510" y="614723"/>
            <a:ext cx="8970490" cy="5843846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15046" y="312174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630706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29321" y="745516"/>
            <a:ext cx="828535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. Sequence comparisons of the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between SP and B73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NA alignment of 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Ss between SP and B73. B73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m00001eb01437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rbors a 1-bp insertion and a 1-bp deletion (without color) in the CDS, resulting in a gene-frame shift. In addition, other uncolored sequences indicate deletions with lengths that are exact multiples of three. (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otein alignment of 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between SP and B73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6221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1789888-D492-67F4-2349-9ECDE2263A1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9116" y="369332"/>
            <a:ext cx="3915020" cy="262536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66ABD8D-B746-82E4-EB14-4928E85797A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56" y="369332"/>
            <a:ext cx="3915019" cy="262536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F1B424F-30A5-684F-A705-2D6AD66C66BD}"/>
              </a:ext>
            </a:extLst>
          </p:cNvPr>
          <p:cNvSpPr txBox="1"/>
          <p:nvPr/>
        </p:nvSpPr>
        <p:spPr>
          <a:xfrm>
            <a:off x="196614" y="18856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6E98E5C-E6CD-B902-8013-849AC8BB1EB6}"/>
              </a:ext>
            </a:extLst>
          </p:cNvPr>
          <p:cNvSpPr txBox="1"/>
          <p:nvPr/>
        </p:nvSpPr>
        <p:spPr>
          <a:xfrm>
            <a:off x="196614" y="3051161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822479B-A065-4E8E-34D3-50613E6536BA}"/>
              </a:ext>
            </a:extLst>
          </p:cNvPr>
          <p:cNvSpPr txBox="1"/>
          <p:nvPr/>
        </p:nvSpPr>
        <p:spPr>
          <a:xfrm>
            <a:off x="4430312" y="9428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3EDABFD-3E6A-6410-78A5-8A417B2008F5}"/>
              </a:ext>
            </a:extLst>
          </p:cNvPr>
          <p:cNvSpPr txBox="1"/>
          <p:nvPr/>
        </p:nvSpPr>
        <p:spPr>
          <a:xfrm>
            <a:off x="4430686" y="3041787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84ADF24F-EB65-A949-7E32-1AEF3C1EC22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9826" y="3151434"/>
            <a:ext cx="2133600" cy="23495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FEF06DF-0D45-4AC8-094E-AEE32CDCA91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356" y="3013501"/>
            <a:ext cx="3915019" cy="2625366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90A3B6B2-941A-0A6D-03D9-6FAED623DCAB}"/>
              </a:ext>
            </a:extLst>
          </p:cNvPr>
          <p:cNvSpPr txBox="1"/>
          <p:nvPr/>
        </p:nvSpPr>
        <p:spPr>
          <a:xfrm>
            <a:off x="324585" y="5500934"/>
            <a:ext cx="84948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W1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ion lines phenotype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b)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W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ion lines driven by the ubiquitin promoter. Scale bar, 1 mm. (c)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W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op upon heating</a:t>
            </a:r>
            <a:r>
              <a:rPr lang="en-US" altLang="zh-CN" sz="1800" dirty="0">
                <a:latin typeface="Times New Roman" panose="02020603050405020304" pitchFamily="18" charset="0"/>
                <a:ea typeface="DengXian" panose="02010600030101010101" pitchFamily="2" charset="-122"/>
              </a:rPr>
              <a:t>,</a:t>
            </a:r>
            <a:r>
              <a:rPr lang="zh-CN" altLang="en-US" sz="1800" dirty="0"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unlike wild-type kernel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, 1 mm. (d) 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W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 exhibits harder kernel than the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wild-typ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522873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19A69F4-7665-9E75-2AAF-5FE60056A4D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808" y="0"/>
            <a:ext cx="7214385" cy="549667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BC5EC21-8E56-AC4B-2ACD-E75735B6C4D5}"/>
              </a:ext>
            </a:extLst>
          </p:cNvPr>
          <p:cNvSpPr txBox="1"/>
          <p:nvPr/>
        </p:nvSpPr>
        <p:spPr>
          <a:xfrm>
            <a:off x="292145" y="5496674"/>
            <a:ext cx="87491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0. XP-CLR</a:t>
            </a:r>
            <a:r>
              <a:rPr lang="zh-CN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5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KEGG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ed terms. </a:t>
            </a:r>
          </a:p>
          <a:p>
            <a:r>
              <a:rPr lang="haw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bubble represents a significantly enriched KEGG pathway, with its size proportional to the number of associated genes. The top five enriched pathways (p &lt; 0.05) are displayed based on statistical significanc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571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A719A97-6FE5-0413-F7FB-A1AE87712ED4}"/>
              </a:ext>
            </a:extLst>
          </p:cNvPr>
          <p:cNvSpPr txBox="1"/>
          <p:nvPr/>
        </p:nvSpPr>
        <p:spPr>
          <a:xfrm>
            <a:off x="361624" y="318154"/>
            <a:ext cx="848178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The F</a:t>
            </a:r>
            <a:r>
              <a:rPr kumimoji="1"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 derived from crosses between SP and MS71</a:t>
            </a:r>
            <a:r>
              <a:rPr lang="haw-US" altLang="zh-CN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600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d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Phenotypic comparisons between the two parents Strawberry Popcorn (SP) and MS71 from  plant architecture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ear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kernel row number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and grain size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 Genetic map of the SP-MS71 F</a:t>
            </a:r>
            <a:r>
              <a:rPr lang="en-US" altLang="zh-CN" sz="16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opulation with 286 individuals.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The genotypes of 286 F</a:t>
            </a:r>
            <a:r>
              <a:rPr lang="en-US" altLang="zh-CN" sz="16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. The red, blue and green bars indicate the SP, heterozygous, and MS71 alleles.</a:t>
            </a:r>
          </a:p>
        </p:txBody>
      </p:sp>
    </p:spTree>
    <p:extLst>
      <p:ext uri="{BB962C8B-B14F-4D97-AF65-F5344CB8AC3E}">
        <p14:creationId xmlns:p14="http://schemas.microsoft.com/office/powerpoint/2010/main" val="6447150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E36D6391-F770-42A9-AB0D-F9D29051D4E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293991" y="0"/>
            <a:ext cx="6436845" cy="359941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F1904C7E-08DF-4FBF-84C1-8FC2DC2403B8}"/>
              </a:ext>
            </a:extLst>
          </p:cNvPr>
          <p:cNvPicPr/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293991" y="3599411"/>
            <a:ext cx="6378656" cy="3258589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3" name="直接连接符 2"/>
          <p:cNvCxnSpPr/>
          <p:nvPr/>
        </p:nvCxnSpPr>
        <p:spPr>
          <a:xfrm>
            <a:off x="7911737" y="4516016"/>
            <a:ext cx="324000" cy="0"/>
          </a:xfrm>
          <a:prstGeom prst="line">
            <a:avLst/>
          </a:prstGeom>
          <a:ln w="38100">
            <a:solidFill>
              <a:srgbClr val="DE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7911737" y="5687319"/>
            <a:ext cx="324000" cy="0"/>
          </a:xfrm>
          <a:prstGeom prst="line">
            <a:avLst/>
          </a:prstGeom>
          <a:ln w="38100">
            <a:solidFill>
              <a:srgbClr val="85BD5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7911737" y="5082695"/>
            <a:ext cx="324000" cy="0"/>
          </a:xfrm>
          <a:prstGeom prst="line">
            <a:avLst/>
          </a:prstGeom>
          <a:ln w="38100">
            <a:solidFill>
              <a:srgbClr val="005EA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7871304" y="4198776"/>
            <a:ext cx="589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730836" y="5370079"/>
            <a:ext cx="798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7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822348" y="4784427"/>
            <a:ext cx="1275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09900" y="204545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20165" y="3706027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6113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EA2CB7C-BEAF-145C-60F8-8911AD12E234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5208" y="144335"/>
            <a:ext cx="979657" cy="97965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3AC2514-D3CB-3E57-3E5C-581B6FD0189A}"/>
              </a:ext>
            </a:extLst>
          </p:cNvPr>
          <p:cNvSpPr txBox="1"/>
          <p:nvPr/>
        </p:nvSpPr>
        <p:spPr>
          <a:xfrm>
            <a:off x="370226" y="1128369"/>
            <a:ext cx="8899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 52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A42EE5E-18BF-2E15-10B4-80398CC83634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8797" y="144335"/>
            <a:ext cx="979657" cy="97965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C91E593-EDCD-D817-2312-9BDD961D9073}"/>
              </a:ext>
            </a:extLst>
          </p:cNvPr>
          <p:cNvSpPr txBox="1"/>
          <p:nvPr/>
        </p:nvSpPr>
        <p:spPr>
          <a:xfrm>
            <a:off x="1804847" y="1128369"/>
            <a:ext cx="542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zi8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9296F73-C0EA-A258-86FD-8BA141D058B0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62386" y="144336"/>
            <a:ext cx="979658" cy="97965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4DABF8D-A51D-FE96-F910-A5EC0868D29F}"/>
              </a:ext>
            </a:extLst>
          </p:cNvPr>
          <p:cNvSpPr txBox="1"/>
          <p:nvPr/>
        </p:nvSpPr>
        <p:spPr>
          <a:xfrm>
            <a:off x="3098518" y="1128369"/>
            <a:ext cx="7371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x303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523F5CE3-47B8-012A-B67E-454FB6C0349F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15976" y="134262"/>
            <a:ext cx="979657" cy="97965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E6EB533E-77A1-B68F-098C-9D2874B47A5B}"/>
              </a:ext>
            </a:extLst>
          </p:cNvPr>
          <p:cNvSpPr txBox="1"/>
          <p:nvPr/>
        </p:nvSpPr>
        <p:spPr>
          <a:xfrm>
            <a:off x="4587242" y="1128369"/>
            <a:ext cx="537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9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B309EBC9-6358-5964-4DF8-5DCF04A245C1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69567" y="144336"/>
            <a:ext cx="979656" cy="979656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7F559654-516E-AEFD-6545-BDDF3DCCFD3D}"/>
              </a:ext>
            </a:extLst>
          </p:cNvPr>
          <p:cNvSpPr txBox="1"/>
          <p:nvPr/>
        </p:nvSpPr>
        <p:spPr>
          <a:xfrm>
            <a:off x="5807135" y="1128369"/>
            <a:ext cx="692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h43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C13895B-68E9-6413-81D4-8ED1114C6933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77233" y="155393"/>
            <a:ext cx="979657" cy="979657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EE7A0987-B873-44D4-4807-FC88161125F7}"/>
              </a:ext>
            </a:extLst>
          </p:cNvPr>
          <p:cNvSpPr txBox="1"/>
          <p:nvPr/>
        </p:nvSpPr>
        <p:spPr>
          <a:xfrm>
            <a:off x="6914856" y="1170998"/>
            <a:ext cx="700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h7B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20F86CCE-A250-F02A-73D7-0EA8B278394B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25293" y="144335"/>
            <a:ext cx="990716" cy="990716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05A533BD-9323-590D-3436-01AA35DFB690}"/>
              </a:ext>
            </a:extLst>
          </p:cNvPr>
          <p:cNvSpPr txBox="1"/>
          <p:nvPr/>
        </p:nvSpPr>
        <p:spPr>
          <a:xfrm>
            <a:off x="8238964" y="1170998"/>
            <a:ext cx="808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350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11E5BD85-7A92-52E7-AEE4-06157D55152F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0018" y="1483944"/>
            <a:ext cx="990716" cy="990716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A7D1F5CA-11AE-12BD-3FFA-DAE4ABEE3D15}"/>
              </a:ext>
            </a:extLst>
          </p:cNvPr>
          <p:cNvSpPr txBox="1"/>
          <p:nvPr/>
        </p:nvSpPr>
        <p:spPr>
          <a:xfrm>
            <a:off x="254842" y="2510607"/>
            <a:ext cx="808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358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A90466F6-D160-AE4A-AFB7-98ABA3625554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59137" y="1495002"/>
            <a:ext cx="979657" cy="979657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ACCE0588-B3B8-5657-87F2-6FAD0C7D7364}"/>
              </a:ext>
            </a:extLst>
          </p:cNvPr>
          <p:cNvSpPr txBox="1"/>
          <p:nvPr/>
        </p:nvSpPr>
        <p:spPr>
          <a:xfrm>
            <a:off x="1555114" y="2510607"/>
            <a:ext cx="942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18W</a:t>
            </a:r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26B11802-BB4C-BB0A-B51C-DD75BDD6609D}"/>
              </a:ext>
            </a:extLst>
          </p:cNvPr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7197" y="1483944"/>
            <a:ext cx="990716" cy="990716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F5B2149C-48A8-EA67-F3DC-40B92977737D}"/>
              </a:ext>
            </a:extLst>
          </p:cNvPr>
          <p:cNvSpPr txBox="1"/>
          <p:nvPr/>
        </p:nvSpPr>
        <p:spPr>
          <a:xfrm>
            <a:off x="2931310" y="2510607"/>
            <a:ext cx="938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62W</a:t>
            </a: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81E67D1D-2542-F13D-ABA1-B4CA1D59CF56}"/>
              </a:ext>
            </a:extLst>
          </p:cNvPr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70046" y="1486667"/>
            <a:ext cx="979658" cy="979658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78DECA4D-70B8-5A99-2398-0B67BE5FA704}"/>
              </a:ext>
            </a:extLst>
          </p:cNvPr>
          <p:cNvSpPr txBox="1"/>
          <p:nvPr/>
        </p:nvSpPr>
        <p:spPr>
          <a:xfrm>
            <a:off x="4159260" y="2511010"/>
            <a:ext cx="821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37W</a:t>
            </a: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1EDD0E78-4DC6-F19D-4D05-C6F93A439A45}"/>
              </a:ext>
            </a:extLst>
          </p:cNvPr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8208" y="1502196"/>
            <a:ext cx="990716" cy="990716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97CD5EDD-4896-2831-AE34-1FBC856020BB}"/>
              </a:ext>
            </a:extLst>
          </p:cNvPr>
          <p:cNvSpPr txBox="1"/>
          <p:nvPr/>
        </p:nvSpPr>
        <p:spPr>
          <a:xfrm>
            <a:off x="5611126" y="2511010"/>
            <a:ext cx="633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y21</a:t>
            </a: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5AEA840A-CED8-5EC5-0F0C-A11EBE1AB029}"/>
              </a:ext>
            </a:extLst>
          </p:cNvPr>
          <p:cNvPicPr>
            <a:picLocks noChangeAspect="1"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37428" y="1496696"/>
            <a:ext cx="1013911" cy="1013911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4B795005-E8DA-332D-C2E0-ABE450817904}"/>
              </a:ext>
            </a:extLst>
          </p:cNvPr>
          <p:cNvSpPr txBox="1"/>
          <p:nvPr/>
        </p:nvSpPr>
        <p:spPr>
          <a:xfrm>
            <a:off x="6947922" y="2511010"/>
            <a:ext cx="591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11</a:t>
            </a: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C0519255-3008-516B-1B36-8E5F2BBE4844}"/>
              </a:ext>
            </a:extLst>
          </p:cNvPr>
          <p:cNvPicPr>
            <a:picLocks noChangeAspect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99843" y="1496696"/>
            <a:ext cx="1013911" cy="1013911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7CF368DA-BD66-3C75-E851-F6089DD30B92}"/>
              </a:ext>
            </a:extLst>
          </p:cNvPr>
          <p:cNvSpPr txBox="1"/>
          <p:nvPr/>
        </p:nvSpPr>
        <p:spPr>
          <a:xfrm>
            <a:off x="8349169" y="2511010"/>
            <a:ext cx="474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3</a:t>
            </a: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689BC4E0-38BA-D560-C477-1320BC5B3581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9105" y="2962821"/>
            <a:ext cx="1013911" cy="1013911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2C8DCAAC-09BE-865C-AAC2-D385CB42AFC7}"/>
              </a:ext>
            </a:extLst>
          </p:cNvPr>
          <p:cNvSpPr txBox="1"/>
          <p:nvPr/>
        </p:nvSpPr>
        <p:spPr>
          <a:xfrm>
            <a:off x="448892" y="3959929"/>
            <a:ext cx="718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14H</a:t>
            </a: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55626A0B-0FB3-22A0-AFAF-74801B6A2661}"/>
              </a:ext>
            </a:extLst>
          </p:cNvPr>
          <p:cNvPicPr>
            <a:picLocks noChangeAspect="1"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17418" y="2955593"/>
            <a:ext cx="1043640" cy="1043640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0CB6D84D-6DBD-4512-18BE-5BFD6FBA7DC3}"/>
              </a:ext>
            </a:extLst>
          </p:cNvPr>
          <p:cNvSpPr txBox="1"/>
          <p:nvPr/>
        </p:nvSpPr>
        <p:spPr>
          <a:xfrm>
            <a:off x="1630143" y="3976731"/>
            <a:ext cx="798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301</a:t>
            </a: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2F909C72-F2A3-7197-3010-ABA893905BA7}"/>
              </a:ext>
            </a:extLst>
          </p:cNvPr>
          <p:cNvPicPr>
            <a:picLocks noChangeAspect="1"/>
          </p:cNvPicPr>
          <p:nvPr/>
        </p:nvPicPr>
        <p:blipFill>
          <a:blip r:embed="rId1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53038" y="2959941"/>
            <a:ext cx="1019669" cy="1019669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1EC784BF-6411-F796-698E-0CF1E1AB55D2}"/>
              </a:ext>
            </a:extLst>
          </p:cNvPr>
          <p:cNvSpPr txBox="1"/>
          <p:nvPr/>
        </p:nvSpPr>
        <p:spPr>
          <a:xfrm>
            <a:off x="2892454" y="3970307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333</a:t>
            </a: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2157D6E3-3701-4D56-81B8-817265A71449}"/>
              </a:ext>
            </a:extLst>
          </p:cNvPr>
          <p:cNvPicPr>
            <a:picLocks noChangeAspect="1"/>
          </p:cNvPicPr>
          <p:nvPr/>
        </p:nvPicPr>
        <p:blipFill>
          <a:blip r:embed="rId1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3541" y="2985322"/>
            <a:ext cx="1013911" cy="1013911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53395D61-8682-00EF-ECAB-02018CB7770D}"/>
              </a:ext>
            </a:extLst>
          </p:cNvPr>
          <p:cNvSpPr txBox="1"/>
          <p:nvPr/>
        </p:nvSpPr>
        <p:spPr>
          <a:xfrm>
            <a:off x="4293601" y="3976732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322</a:t>
            </a: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8FE6B990-66F8-DEF4-57FE-5585BA21AD0C}"/>
              </a:ext>
            </a:extLst>
          </p:cNvPr>
          <p:cNvPicPr>
            <a:picLocks noChangeAspect="1"/>
          </p:cNvPicPr>
          <p:nvPr/>
        </p:nvPicPr>
        <p:blipFill>
          <a:blip r:embed="rId2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27186" y="3002993"/>
            <a:ext cx="1012821" cy="1012821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C12F96F8-25E5-F596-4F8A-D8C786387CE9}"/>
              </a:ext>
            </a:extLst>
          </p:cNvPr>
          <p:cNvSpPr txBox="1"/>
          <p:nvPr/>
        </p:nvSpPr>
        <p:spPr>
          <a:xfrm>
            <a:off x="5613112" y="3976732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277</a:t>
            </a: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FCB310D5-10CA-61B9-010C-99FDB1C70C2D}"/>
              </a:ext>
            </a:extLst>
          </p:cNvPr>
          <p:cNvPicPr>
            <a:picLocks noChangeAspect="1"/>
          </p:cNvPicPr>
          <p:nvPr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89342" y="2999762"/>
            <a:ext cx="979657" cy="979657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97EDAD68-36DB-87D3-A291-DED420F0B1FB}"/>
              </a:ext>
            </a:extLst>
          </p:cNvPr>
          <p:cNvSpPr txBox="1"/>
          <p:nvPr/>
        </p:nvSpPr>
        <p:spPr>
          <a:xfrm>
            <a:off x="6836953" y="4005567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247</a:t>
            </a: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8245175F-1712-A64A-A0A8-96997FA6C0DD}"/>
              </a:ext>
            </a:extLst>
          </p:cNvPr>
          <p:cNvPicPr>
            <a:picLocks noChangeAspect="1"/>
          </p:cNvPicPr>
          <p:nvPr/>
        </p:nvPicPr>
        <p:blipFill>
          <a:blip r:embed="rId2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60795" y="3002451"/>
            <a:ext cx="974281" cy="974281"/>
          </a:xfrm>
          <a:prstGeom prst="rect">
            <a:avLst/>
          </a:prstGeom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67C8C5E1-3303-AA79-D055-743A2699C800}"/>
              </a:ext>
            </a:extLst>
          </p:cNvPr>
          <p:cNvSpPr txBox="1"/>
          <p:nvPr/>
        </p:nvSpPr>
        <p:spPr>
          <a:xfrm>
            <a:off x="8189893" y="3969504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228</a:t>
            </a: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1290D2EF-B098-EE49-E9A4-462686FF0910}"/>
              </a:ext>
            </a:extLst>
          </p:cNvPr>
          <p:cNvPicPr>
            <a:picLocks noChangeAspect="1"/>
          </p:cNvPicPr>
          <p:nvPr/>
        </p:nvPicPr>
        <p:blipFill>
          <a:blip r:embed="rId2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1195" y="4371258"/>
            <a:ext cx="974280" cy="974280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7F44279E-505F-614E-D551-E635CA955F14}"/>
              </a:ext>
            </a:extLst>
          </p:cNvPr>
          <p:cNvSpPr txBox="1"/>
          <p:nvPr/>
        </p:nvSpPr>
        <p:spPr>
          <a:xfrm>
            <a:off x="308597" y="5381021"/>
            <a:ext cx="95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103</a:t>
            </a: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88B1CC77-BBF9-0A3E-6D6C-F542FD8FA4CD}"/>
              </a:ext>
            </a:extLst>
          </p:cNvPr>
          <p:cNvPicPr>
            <a:picLocks noChangeAspect="1"/>
          </p:cNvPicPr>
          <p:nvPr/>
        </p:nvPicPr>
        <p:blipFill>
          <a:blip r:embed="rId2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59137" y="4406808"/>
            <a:ext cx="1012821" cy="1012821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7857BF26-6ADA-C030-C44B-1C4CBF4943AE}"/>
              </a:ext>
            </a:extLst>
          </p:cNvPr>
          <p:cNvSpPr txBox="1"/>
          <p:nvPr/>
        </p:nvSpPr>
        <p:spPr>
          <a:xfrm>
            <a:off x="1622983" y="5404126"/>
            <a:ext cx="837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L69</a:t>
            </a: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294EF46F-E215-8DE5-D9CC-B7A37C599923}"/>
              </a:ext>
            </a:extLst>
          </p:cNvPr>
          <p:cNvPicPr>
            <a:picLocks noChangeAspect="1"/>
          </p:cNvPicPr>
          <p:nvPr/>
        </p:nvPicPr>
        <p:blipFill>
          <a:blip r:embed="rId2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87631" y="4406808"/>
            <a:ext cx="988353" cy="988353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2FB63484-EE20-CDF7-200F-EED860E20305}"/>
              </a:ext>
            </a:extLst>
          </p:cNvPr>
          <p:cNvSpPr txBox="1"/>
          <p:nvPr/>
        </p:nvSpPr>
        <p:spPr>
          <a:xfrm>
            <a:off x="3086803" y="5404126"/>
            <a:ext cx="543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7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A719A97-6FE5-0413-F7FB-A1AE87712ED4}"/>
              </a:ext>
            </a:extLst>
          </p:cNvPr>
          <p:cNvSpPr txBox="1"/>
          <p:nvPr/>
        </p:nvSpPr>
        <p:spPr>
          <a:xfrm>
            <a:off x="177012" y="5772736"/>
            <a:ext cx="89669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 Genome collinearity of chromosome 8 between SP and the parents from maize NAM Population</a:t>
            </a:r>
            <a:r>
              <a:rPr lang="haw-US" altLang="zh-CN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600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me comparisons reveal the large inversion on chromosome 8. The y-axis represents SP chromosome 8.</a:t>
            </a:r>
            <a:endParaRPr lang="en-US" altLang="zh-CN" sz="160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1042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D755800-FB5D-9B34-2B2B-DAC9BCF4770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3416" y="239197"/>
            <a:ext cx="4817168" cy="448891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9078051-B503-0491-C60C-5BBA947CB56E}"/>
              </a:ext>
            </a:extLst>
          </p:cNvPr>
          <p:cNvSpPr txBox="1"/>
          <p:nvPr/>
        </p:nvSpPr>
        <p:spPr>
          <a:xfrm>
            <a:off x="746335" y="4967602"/>
            <a:ext cx="798400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. </a:t>
            </a:r>
            <a:r>
              <a:rPr lang="haw-US" altLang="zh-CN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enn plot</a:t>
            </a:r>
            <a:r>
              <a:rPr lang="zh-CN" altLang="en-US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haw-US" altLang="zh-CN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mpar</a:t>
            </a:r>
            <a:r>
              <a:rPr lang="en-US" altLang="zh-CN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d</a:t>
            </a:r>
            <a:r>
              <a:rPr lang="haw-US" altLang="zh-CN" b="1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P genes with B73 and MS71.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haw-US" altLang="zh-CN" b="0" i="0" dirty="0">
                <a:solidFill>
                  <a:srgbClr val="060607"/>
                </a:solidFill>
                <a:effectLst/>
                <a:latin typeface="Times New Roman" panose="02020603050405020304" pitchFamily="18" charset="0"/>
                <a:ea typeface="SimHei" panose="02010609060101010101" pitchFamily="49" charset="-122"/>
                <a:cs typeface="Times New Roman" panose="02020603050405020304" pitchFamily="18" charset="0"/>
              </a:rPr>
              <a:t>Genes were compared using blastn with an E-value threshold of 1e-5, and the best hit was selected.</a:t>
            </a:r>
            <a:endParaRPr lang="en-US" altLang="zh-CN" dirty="0">
              <a:latin typeface="Times New Roman" panose="02020603050405020304" pitchFamily="18" charset="0"/>
              <a:ea typeface="SimHei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69417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689A0D2-3B35-765D-3FB2-B1104B00F1F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16624" y="275290"/>
            <a:ext cx="5896268" cy="494510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5A719A97-6FE5-0413-F7FB-A1AE87712ED4}"/>
              </a:ext>
            </a:extLst>
          </p:cNvPr>
          <p:cNvSpPr txBox="1"/>
          <p:nvPr/>
        </p:nvSpPr>
        <p:spPr>
          <a:xfrm>
            <a:off x="90021" y="5542873"/>
            <a:ext cx="872146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. The causal site of  the key flowering time gene </a:t>
            </a:r>
            <a:r>
              <a:rPr kumimoji="1"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mCCT10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kumimoji="1" lang="en-US" altLang="zh-CN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 10.</a:t>
            </a:r>
          </a:p>
          <a:p>
            <a:r>
              <a:rPr kumimoji="1"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oth SP and MS71 contain the 5-kb insertion in the promoter of</a:t>
            </a:r>
            <a:r>
              <a:rPr kumimoji="1" lang="en-US" altLang="zh-CN" sz="16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ZmCCT10 </a:t>
            </a:r>
            <a:r>
              <a:rPr kumimoji="1"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the causal site</a:t>
            </a:r>
            <a:r>
              <a:rPr kumimoji="1"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thus the QTL of flowering time corresponding to </a:t>
            </a:r>
            <a:r>
              <a:rPr kumimoji="1" lang="en-US" altLang="zh-CN" sz="16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ZmCC10 </a:t>
            </a:r>
            <a:r>
              <a:rPr kumimoji="1"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 absent in the F</a:t>
            </a:r>
            <a:r>
              <a:rPr kumimoji="1" lang="en-US" altLang="zh-CN" sz="16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zh-CN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pulation between SP and MS71.</a:t>
            </a:r>
            <a:endParaRPr lang="en-US" altLang="zh-CN" sz="160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66983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" name="组合 98">
            <a:extLst>
              <a:ext uri="{FF2B5EF4-FFF2-40B4-BE49-F238E27FC236}">
                <a16:creationId xmlns:a16="http://schemas.microsoft.com/office/drawing/2014/main" id="{B7B3DD24-22A5-8A9F-1A57-47B909EF788F}"/>
              </a:ext>
            </a:extLst>
          </p:cNvPr>
          <p:cNvGrpSpPr/>
          <p:nvPr/>
        </p:nvGrpSpPr>
        <p:grpSpPr>
          <a:xfrm>
            <a:off x="4583208" y="1045669"/>
            <a:ext cx="4173182" cy="4422494"/>
            <a:chOff x="4583208" y="1045669"/>
            <a:chExt cx="4173182" cy="4422494"/>
          </a:xfrm>
        </p:grpSpPr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63024EC0-FF53-C0A8-D509-B8B3B20D7E6B}"/>
                </a:ext>
              </a:extLst>
            </p:cNvPr>
            <p:cNvGrpSpPr/>
            <p:nvPr/>
          </p:nvGrpSpPr>
          <p:grpSpPr>
            <a:xfrm>
              <a:off x="4583208" y="1045669"/>
              <a:ext cx="4173182" cy="4422494"/>
              <a:chOff x="4583208" y="1045669"/>
              <a:chExt cx="4173182" cy="4422494"/>
            </a:xfrm>
          </p:grpSpPr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34E64929-6973-092D-8F36-38F400A409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633" b="7249"/>
              <a:stretch/>
            </p:blipFill>
            <p:spPr>
              <a:xfrm>
                <a:off x="4583208" y="1045669"/>
                <a:ext cx="4173182" cy="4422494"/>
              </a:xfrm>
              <a:prstGeom prst="rect">
                <a:avLst/>
              </a:prstGeom>
            </p:spPr>
          </p:pic>
          <p:pic>
            <p:nvPicPr>
              <p:cNvPr id="97" name="图片 96">
                <a:extLst>
                  <a:ext uri="{FF2B5EF4-FFF2-40B4-BE49-F238E27FC236}">
                    <a16:creationId xmlns:a16="http://schemas.microsoft.com/office/drawing/2014/main" id="{E3100B9B-DC24-FC97-28F9-E26A8D0781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flipV="1">
                <a:off x="5452907" y="5247161"/>
                <a:ext cx="119401" cy="102344"/>
              </a:xfrm>
              <a:prstGeom prst="rect">
                <a:avLst/>
              </a:prstGeom>
            </p:spPr>
          </p:pic>
        </p:grpSp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5FEF7853-02B1-22A5-D7E4-040CBEC22E4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26971" y="5261539"/>
              <a:ext cx="93054" cy="97827"/>
            </a:xfrm>
            <a:prstGeom prst="rect">
              <a:avLst/>
            </a:prstGeom>
          </p:spPr>
        </p:pic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03E526B4-5DC5-AAF4-8007-5FCA97DD8413}"/>
              </a:ext>
            </a:extLst>
          </p:cNvPr>
          <p:cNvSpPr txBox="1"/>
          <p:nvPr/>
        </p:nvSpPr>
        <p:spPr>
          <a:xfrm>
            <a:off x="263485" y="5766974"/>
            <a:ext cx="863944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zh-CN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. </a:t>
            </a:r>
            <a:r>
              <a:rPr kumimoji="1" lang="en-US" altLang="zh-CN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m</a:t>
            </a:r>
            <a:r>
              <a:rPr lang="haw-US" altLang="zh-CN" sz="16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lang="haw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 structure of 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haw-US" altLang="zh-C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osinte</a:t>
            </a:r>
          </a:p>
          <a:p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opy number of genes at the </a:t>
            </a:r>
            <a:r>
              <a:rPr kumimoji="1" lang="haw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in the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osinte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aw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ea</a:t>
            </a:r>
            <a:r>
              <a:rPr lang="haw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aw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ys</a:t>
            </a:r>
            <a:r>
              <a:rPr lang="haw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ubsp</a:t>
            </a:r>
            <a:r>
              <a:rPr lang="haw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aw-US" altLang="zh-CN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aw-US" altLang="zh-CN" sz="16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viglumis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e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y 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haw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t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lose gene function, while black bars represent </a:t>
            </a:r>
            <a:r>
              <a:rPr kumimoji="1"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1</a:t>
            </a:r>
            <a:r>
              <a:rPr kumimoji="1"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have normal gene function. Blank box, intron; Triangle, variants resulting in loss of function.</a:t>
            </a:r>
            <a:endParaRPr kumimoji="1" lang="haw-US" altLang="zh-C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CC7544C-141E-C3D8-C527-12BCFA570D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559"/>
          <a:stretch/>
        </p:blipFill>
        <p:spPr>
          <a:xfrm>
            <a:off x="4698285" y="193586"/>
            <a:ext cx="4346310" cy="97269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E783C2A-5068-4E0A-3FAB-7C3047F12A2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9628" y="314200"/>
            <a:ext cx="4086683" cy="73146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CA1C46C-530E-0654-F556-7B2FE382FE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7052" y="1000508"/>
            <a:ext cx="3607088" cy="4564448"/>
          </a:xfrm>
          <a:prstGeom prst="rect">
            <a:avLst/>
          </a:prstGeom>
        </p:spPr>
      </p:pic>
      <p:grpSp>
        <p:nvGrpSpPr>
          <p:cNvPr id="57" name="组合 56">
            <a:extLst>
              <a:ext uri="{FF2B5EF4-FFF2-40B4-BE49-F238E27FC236}">
                <a16:creationId xmlns:a16="http://schemas.microsoft.com/office/drawing/2014/main" id="{3B962E68-5042-4FB3-4737-1C7F2DF7C355}"/>
              </a:ext>
            </a:extLst>
          </p:cNvPr>
          <p:cNvGrpSpPr/>
          <p:nvPr/>
        </p:nvGrpSpPr>
        <p:grpSpPr>
          <a:xfrm>
            <a:off x="3821131" y="1301984"/>
            <a:ext cx="649811" cy="3294056"/>
            <a:chOff x="3821131" y="1301984"/>
            <a:chExt cx="649811" cy="3294056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23B5CBC-C5FD-FC87-1126-E4A847FE9C5A}"/>
                </a:ext>
              </a:extLst>
            </p:cNvPr>
            <p:cNvSpPr txBox="1"/>
            <p:nvPr/>
          </p:nvSpPr>
          <p:spPr>
            <a:xfrm>
              <a:off x="3862027" y="147701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9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09F5386-18F1-FBA8-F43A-F81BCA4CE2E7}"/>
                </a:ext>
              </a:extLst>
            </p:cNvPr>
            <p:cNvSpPr txBox="1"/>
            <p:nvPr/>
          </p:nvSpPr>
          <p:spPr>
            <a:xfrm>
              <a:off x="3862027" y="174039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FADE3F3-36A0-3E32-EDA3-B1B0F2CD06FE}"/>
                </a:ext>
              </a:extLst>
            </p:cNvPr>
            <p:cNvSpPr txBox="1"/>
            <p:nvPr/>
          </p:nvSpPr>
          <p:spPr>
            <a:xfrm>
              <a:off x="3862027" y="194722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BF9D3EA-4D18-BB5C-4F83-6B81079926C6}"/>
                </a:ext>
              </a:extLst>
            </p:cNvPr>
            <p:cNvSpPr txBox="1"/>
            <p:nvPr/>
          </p:nvSpPr>
          <p:spPr>
            <a:xfrm>
              <a:off x="3851024" y="2190893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F31D326-77A4-FB35-AF70-34ABBBBED23A}"/>
                </a:ext>
              </a:extLst>
            </p:cNvPr>
            <p:cNvSpPr txBox="1"/>
            <p:nvPr/>
          </p:nvSpPr>
          <p:spPr>
            <a:xfrm>
              <a:off x="3856435" y="2438924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911A1CA-84F6-41C6-A85C-81ECD5E25E08}"/>
                </a:ext>
              </a:extLst>
            </p:cNvPr>
            <p:cNvSpPr txBox="1"/>
            <p:nvPr/>
          </p:nvSpPr>
          <p:spPr>
            <a:xfrm>
              <a:off x="3862027" y="2686955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92B7B1F-2052-44BE-D85F-767908F934C9}"/>
                </a:ext>
              </a:extLst>
            </p:cNvPr>
            <p:cNvSpPr txBox="1"/>
            <p:nvPr/>
          </p:nvSpPr>
          <p:spPr>
            <a:xfrm>
              <a:off x="3862027" y="292492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6553596-0A94-ACB4-3620-B4EB7E70AA32}"/>
                </a:ext>
              </a:extLst>
            </p:cNvPr>
            <p:cNvSpPr txBox="1"/>
            <p:nvPr/>
          </p:nvSpPr>
          <p:spPr>
            <a:xfrm>
              <a:off x="3862027" y="3206605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FBC7BF2A-AD48-C786-AD21-A8676E0B28D0}"/>
                </a:ext>
              </a:extLst>
            </p:cNvPr>
            <p:cNvSpPr txBox="1"/>
            <p:nvPr/>
          </p:nvSpPr>
          <p:spPr>
            <a:xfrm>
              <a:off x="3862027" y="3488282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4933CC60-19BB-A7F2-C236-4DE57689F205}"/>
                </a:ext>
              </a:extLst>
            </p:cNvPr>
            <p:cNvSpPr txBox="1"/>
            <p:nvPr/>
          </p:nvSpPr>
          <p:spPr>
            <a:xfrm>
              <a:off x="3862027" y="373472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3AA39EF-3EB5-FD3D-E3C9-63F6766565D7}"/>
                </a:ext>
              </a:extLst>
            </p:cNvPr>
            <p:cNvSpPr txBox="1"/>
            <p:nvPr/>
          </p:nvSpPr>
          <p:spPr>
            <a:xfrm>
              <a:off x="3862027" y="4035467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BE1FCE2-2EF7-14A5-7E49-1380B4E0DFD5}"/>
                </a:ext>
              </a:extLst>
            </p:cNvPr>
            <p:cNvSpPr txBox="1"/>
            <p:nvPr/>
          </p:nvSpPr>
          <p:spPr>
            <a:xfrm>
              <a:off x="3862027" y="437273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431F5059-C495-F24B-DCB5-584A704C02A9}"/>
                </a:ext>
              </a:extLst>
            </p:cNvPr>
            <p:cNvSpPr txBox="1"/>
            <p:nvPr/>
          </p:nvSpPr>
          <p:spPr>
            <a:xfrm>
              <a:off x="3821131" y="1301984"/>
              <a:ext cx="34817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P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0232390-EBF0-4054-0195-839F193F4071}"/>
                </a:ext>
              </a:extLst>
            </p:cNvPr>
            <p:cNvSpPr txBox="1"/>
            <p:nvPr/>
          </p:nvSpPr>
          <p:spPr>
            <a:xfrm>
              <a:off x="4158599" y="147701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94EFC91-9E60-6728-C6DB-1F80E282777A}"/>
                </a:ext>
              </a:extLst>
            </p:cNvPr>
            <p:cNvSpPr txBox="1"/>
            <p:nvPr/>
          </p:nvSpPr>
          <p:spPr>
            <a:xfrm>
              <a:off x="4158599" y="174039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3D179390-5DA5-F343-7B6E-9B39F9804669}"/>
                </a:ext>
              </a:extLst>
            </p:cNvPr>
            <p:cNvSpPr txBox="1"/>
            <p:nvPr/>
          </p:nvSpPr>
          <p:spPr>
            <a:xfrm>
              <a:off x="4158599" y="194722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78740D56-3E2A-D6EE-BF2C-BE042F93E74E}"/>
                </a:ext>
              </a:extLst>
            </p:cNvPr>
            <p:cNvSpPr txBox="1"/>
            <p:nvPr/>
          </p:nvSpPr>
          <p:spPr>
            <a:xfrm>
              <a:off x="4153105" y="219507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4D1AD00D-DC0D-9886-48A4-898344995403}"/>
                </a:ext>
              </a:extLst>
            </p:cNvPr>
            <p:cNvSpPr txBox="1"/>
            <p:nvPr/>
          </p:nvSpPr>
          <p:spPr>
            <a:xfrm>
              <a:off x="4158599" y="2442096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2BEFC141-5715-8D36-7569-C5BEAF16A66A}"/>
                </a:ext>
              </a:extLst>
            </p:cNvPr>
            <p:cNvSpPr txBox="1"/>
            <p:nvPr/>
          </p:nvSpPr>
          <p:spPr>
            <a:xfrm>
              <a:off x="4158599" y="268636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A664BD2-17D2-7A61-0E44-E3883E3246ED}"/>
                </a:ext>
              </a:extLst>
            </p:cNvPr>
            <p:cNvSpPr txBox="1"/>
            <p:nvPr/>
          </p:nvSpPr>
          <p:spPr>
            <a:xfrm>
              <a:off x="4158599" y="2924929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6257F60-165F-3609-C5AB-2D0FBA27A1B2}"/>
                </a:ext>
              </a:extLst>
            </p:cNvPr>
            <p:cNvSpPr txBox="1"/>
            <p:nvPr/>
          </p:nvSpPr>
          <p:spPr>
            <a:xfrm>
              <a:off x="4163769" y="3206605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A37573B0-1064-4A54-77DC-C873A3BACDE9}"/>
                </a:ext>
              </a:extLst>
            </p:cNvPr>
            <p:cNvSpPr txBox="1"/>
            <p:nvPr/>
          </p:nvSpPr>
          <p:spPr>
            <a:xfrm>
              <a:off x="4158599" y="3488282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ED3AAD7-3699-48D4-F398-1946E48807D0}"/>
                </a:ext>
              </a:extLst>
            </p:cNvPr>
            <p:cNvSpPr txBox="1"/>
            <p:nvPr/>
          </p:nvSpPr>
          <p:spPr>
            <a:xfrm>
              <a:off x="4158599" y="374247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CF2A8CB-C723-044F-8F67-FFC73D01E490}"/>
                </a:ext>
              </a:extLst>
            </p:cNvPr>
            <p:cNvSpPr txBox="1"/>
            <p:nvPr/>
          </p:nvSpPr>
          <p:spPr>
            <a:xfrm>
              <a:off x="4158599" y="4035467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0C7559E-A88D-796A-812A-12C1A145A4C9}"/>
                </a:ext>
              </a:extLst>
            </p:cNvPr>
            <p:cNvSpPr txBox="1"/>
            <p:nvPr/>
          </p:nvSpPr>
          <p:spPr>
            <a:xfrm>
              <a:off x="4158599" y="4372738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5D199BE3-96A4-0062-5C2C-AAC44A91C4F2}"/>
                </a:ext>
              </a:extLst>
            </p:cNvPr>
            <p:cNvSpPr txBox="1"/>
            <p:nvPr/>
          </p:nvSpPr>
          <p:spPr>
            <a:xfrm>
              <a:off x="4081092" y="1301984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l</a:t>
              </a:r>
              <a:endParaRPr kumimoji="1"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直线连接符 49">
              <a:extLst>
                <a:ext uri="{FF2B5EF4-FFF2-40B4-BE49-F238E27FC236}">
                  <a16:creationId xmlns:a16="http://schemas.microsoft.com/office/drawing/2014/main" id="{3E0F5E10-1010-FB90-156E-EB601FB74AD9}"/>
                </a:ext>
              </a:extLst>
            </p:cNvPr>
            <p:cNvCxnSpPr>
              <a:cxnSpLocks/>
            </p:cNvCxnSpPr>
            <p:nvPr/>
          </p:nvCxnSpPr>
          <p:spPr>
            <a:xfrm>
              <a:off x="4136461" y="1493880"/>
              <a:ext cx="0" cy="310216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线连接符 52">
              <a:extLst>
                <a:ext uri="{FF2B5EF4-FFF2-40B4-BE49-F238E27FC236}">
                  <a16:creationId xmlns:a16="http://schemas.microsoft.com/office/drawing/2014/main" id="{247FCCB6-435C-45AC-0910-10170636FC0A}"/>
                </a:ext>
              </a:extLst>
            </p:cNvPr>
            <p:cNvCxnSpPr>
              <a:cxnSpLocks/>
            </p:cNvCxnSpPr>
            <p:nvPr/>
          </p:nvCxnSpPr>
          <p:spPr>
            <a:xfrm>
              <a:off x="3854141" y="1493980"/>
              <a:ext cx="6089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线连接符 54">
              <a:extLst>
                <a:ext uri="{FF2B5EF4-FFF2-40B4-BE49-F238E27FC236}">
                  <a16:creationId xmlns:a16="http://schemas.microsoft.com/office/drawing/2014/main" id="{B2FC2912-3A89-529A-EBB6-3C2755D4C762}"/>
                </a:ext>
              </a:extLst>
            </p:cNvPr>
            <p:cNvCxnSpPr>
              <a:cxnSpLocks/>
            </p:cNvCxnSpPr>
            <p:nvPr/>
          </p:nvCxnSpPr>
          <p:spPr>
            <a:xfrm>
              <a:off x="3854140" y="1327668"/>
              <a:ext cx="6089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线连接符 55">
              <a:extLst>
                <a:ext uri="{FF2B5EF4-FFF2-40B4-BE49-F238E27FC236}">
                  <a16:creationId xmlns:a16="http://schemas.microsoft.com/office/drawing/2014/main" id="{230BFF30-71DD-3BEA-9D68-71802DF08EA1}"/>
                </a:ext>
              </a:extLst>
            </p:cNvPr>
            <p:cNvCxnSpPr>
              <a:cxnSpLocks/>
            </p:cNvCxnSpPr>
            <p:nvPr/>
          </p:nvCxnSpPr>
          <p:spPr>
            <a:xfrm>
              <a:off x="3854139" y="4596040"/>
              <a:ext cx="6089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9" name="文本框 58">
            <a:extLst>
              <a:ext uri="{FF2B5EF4-FFF2-40B4-BE49-F238E27FC236}">
                <a16:creationId xmlns:a16="http://schemas.microsoft.com/office/drawing/2014/main" id="{A6C22D38-DE75-857D-D12F-1FE230BFF6CC}"/>
              </a:ext>
            </a:extLst>
          </p:cNvPr>
          <p:cNvSpPr txBox="1"/>
          <p:nvPr/>
        </p:nvSpPr>
        <p:spPr>
          <a:xfrm>
            <a:off x="8432320" y="147320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8F1CCEC4-1FF8-9779-1E6D-E9EBCBC584C1}"/>
              </a:ext>
            </a:extLst>
          </p:cNvPr>
          <p:cNvSpPr txBox="1"/>
          <p:nvPr/>
        </p:nvSpPr>
        <p:spPr>
          <a:xfrm>
            <a:off x="8418549" y="172486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F3DA9E1-903D-5720-5B59-49F9260F85CF}"/>
              </a:ext>
            </a:extLst>
          </p:cNvPr>
          <p:cNvSpPr txBox="1"/>
          <p:nvPr/>
        </p:nvSpPr>
        <p:spPr>
          <a:xfrm>
            <a:off x="8432320" y="194341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7FCBC4EF-7F16-2A57-C220-3F2BE251CA2A}"/>
              </a:ext>
            </a:extLst>
          </p:cNvPr>
          <p:cNvSpPr txBox="1"/>
          <p:nvPr/>
        </p:nvSpPr>
        <p:spPr>
          <a:xfrm>
            <a:off x="8432320" y="223545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063E82E9-30D4-A30F-1A3D-A65741A3C2ED}"/>
              </a:ext>
            </a:extLst>
          </p:cNvPr>
          <p:cNvSpPr txBox="1"/>
          <p:nvPr/>
        </p:nvSpPr>
        <p:spPr>
          <a:xfrm>
            <a:off x="8432320" y="247474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ACAEB6E-00DA-D709-E0FA-22EC7C2010C3}"/>
              </a:ext>
            </a:extLst>
          </p:cNvPr>
          <p:cNvSpPr txBox="1"/>
          <p:nvPr/>
        </p:nvSpPr>
        <p:spPr>
          <a:xfrm>
            <a:off x="8432320" y="274133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5CC7D72-2A38-051C-2581-ABABE3EB9309}"/>
              </a:ext>
            </a:extLst>
          </p:cNvPr>
          <p:cNvSpPr txBox="1"/>
          <p:nvPr/>
        </p:nvSpPr>
        <p:spPr>
          <a:xfrm>
            <a:off x="8432320" y="29596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D1EF580-BA76-FE69-869F-E923E6621ECD}"/>
              </a:ext>
            </a:extLst>
          </p:cNvPr>
          <p:cNvSpPr txBox="1"/>
          <p:nvPr/>
        </p:nvSpPr>
        <p:spPr>
          <a:xfrm>
            <a:off x="8432320" y="379290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2DF58DF-4FDB-2C7E-5342-861F7C526571}"/>
              </a:ext>
            </a:extLst>
          </p:cNvPr>
          <p:cNvSpPr txBox="1"/>
          <p:nvPr/>
        </p:nvSpPr>
        <p:spPr>
          <a:xfrm>
            <a:off x="8417125" y="46942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611F13EC-C041-2CEF-F2BF-438D148EF439}"/>
              </a:ext>
            </a:extLst>
          </p:cNvPr>
          <p:cNvSpPr txBox="1"/>
          <p:nvPr/>
        </p:nvSpPr>
        <p:spPr>
          <a:xfrm>
            <a:off x="8404636" y="526389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FB15E1D6-64AF-A1D2-5DCF-4A6C8B74D3D6}"/>
              </a:ext>
            </a:extLst>
          </p:cNvPr>
          <p:cNvSpPr txBox="1"/>
          <p:nvPr/>
        </p:nvSpPr>
        <p:spPr>
          <a:xfrm>
            <a:off x="8391424" y="1298171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C701AE17-2D88-763C-3688-A8949AA1FDCA}"/>
              </a:ext>
            </a:extLst>
          </p:cNvPr>
          <p:cNvSpPr txBox="1"/>
          <p:nvPr/>
        </p:nvSpPr>
        <p:spPr>
          <a:xfrm>
            <a:off x="8728892" y="147320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19CBE26-82CA-844A-03BF-21A75F413584}"/>
              </a:ext>
            </a:extLst>
          </p:cNvPr>
          <p:cNvSpPr txBox="1"/>
          <p:nvPr/>
        </p:nvSpPr>
        <p:spPr>
          <a:xfrm>
            <a:off x="8728892" y="172306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314DB2E7-8E3A-170E-EF22-2BC3F8E2CC33}"/>
              </a:ext>
            </a:extLst>
          </p:cNvPr>
          <p:cNvSpPr txBox="1"/>
          <p:nvPr/>
        </p:nvSpPr>
        <p:spPr>
          <a:xfrm>
            <a:off x="8728892" y="194341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1995220-A517-E31D-745D-505D15C90FC7}"/>
              </a:ext>
            </a:extLst>
          </p:cNvPr>
          <p:cNvSpPr txBox="1"/>
          <p:nvPr/>
        </p:nvSpPr>
        <p:spPr>
          <a:xfrm>
            <a:off x="8728892" y="2235451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2CF3A218-A076-D514-8601-70FD914F1722}"/>
              </a:ext>
            </a:extLst>
          </p:cNvPr>
          <p:cNvSpPr txBox="1"/>
          <p:nvPr/>
        </p:nvSpPr>
        <p:spPr>
          <a:xfrm>
            <a:off x="8728892" y="247474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54A9D241-FDF6-606A-7EC3-D80F963D8742}"/>
              </a:ext>
            </a:extLst>
          </p:cNvPr>
          <p:cNvSpPr txBox="1"/>
          <p:nvPr/>
        </p:nvSpPr>
        <p:spPr>
          <a:xfrm>
            <a:off x="8728892" y="2741331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0532F8D5-7819-1161-7FDC-AFFEF62FE5A1}"/>
              </a:ext>
            </a:extLst>
          </p:cNvPr>
          <p:cNvSpPr txBox="1"/>
          <p:nvPr/>
        </p:nvSpPr>
        <p:spPr>
          <a:xfrm>
            <a:off x="8728892" y="295968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519B2BCC-5F56-0959-E570-775D23043071}"/>
              </a:ext>
            </a:extLst>
          </p:cNvPr>
          <p:cNvSpPr txBox="1"/>
          <p:nvPr/>
        </p:nvSpPr>
        <p:spPr>
          <a:xfrm>
            <a:off x="8728892" y="3792908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53DC709D-303E-7E55-8FAD-CEAC6CCEB770}"/>
              </a:ext>
            </a:extLst>
          </p:cNvPr>
          <p:cNvSpPr txBox="1"/>
          <p:nvPr/>
        </p:nvSpPr>
        <p:spPr>
          <a:xfrm>
            <a:off x="8770161" y="4694217"/>
            <a:ext cx="1740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AE096554-9DF0-913C-764F-E1C1AFD765ED}"/>
              </a:ext>
            </a:extLst>
          </p:cNvPr>
          <p:cNvSpPr txBox="1"/>
          <p:nvPr/>
        </p:nvSpPr>
        <p:spPr>
          <a:xfrm>
            <a:off x="8758370" y="5263895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24CE3608-33AD-A3AA-A7DE-5D416E56478F}"/>
              </a:ext>
            </a:extLst>
          </p:cNvPr>
          <p:cNvSpPr txBox="1"/>
          <p:nvPr/>
        </p:nvSpPr>
        <p:spPr>
          <a:xfrm>
            <a:off x="8651385" y="1298171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endParaRPr kumimoji="1"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线连接符 84">
            <a:extLst>
              <a:ext uri="{FF2B5EF4-FFF2-40B4-BE49-F238E27FC236}">
                <a16:creationId xmlns:a16="http://schemas.microsoft.com/office/drawing/2014/main" id="{DF04C9D9-0D0B-1479-8FCD-AEF47CAC6603}"/>
              </a:ext>
            </a:extLst>
          </p:cNvPr>
          <p:cNvCxnSpPr>
            <a:cxnSpLocks/>
          </p:cNvCxnSpPr>
          <p:nvPr/>
        </p:nvCxnSpPr>
        <p:spPr>
          <a:xfrm>
            <a:off x="8706754" y="1490067"/>
            <a:ext cx="0" cy="39780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线连接符 85">
            <a:extLst>
              <a:ext uri="{FF2B5EF4-FFF2-40B4-BE49-F238E27FC236}">
                <a16:creationId xmlns:a16="http://schemas.microsoft.com/office/drawing/2014/main" id="{6213F6AD-FEDB-A9B6-B6E2-B29643CFFE25}"/>
              </a:ext>
            </a:extLst>
          </p:cNvPr>
          <p:cNvCxnSpPr>
            <a:cxnSpLocks/>
          </p:cNvCxnSpPr>
          <p:nvPr/>
        </p:nvCxnSpPr>
        <p:spPr>
          <a:xfrm>
            <a:off x="8424434" y="1490167"/>
            <a:ext cx="6089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线连接符 86">
            <a:extLst>
              <a:ext uri="{FF2B5EF4-FFF2-40B4-BE49-F238E27FC236}">
                <a16:creationId xmlns:a16="http://schemas.microsoft.com/office/drawing/2014/main" id="{FEC5F7E2-29B0-DFAE-812E-7904573E37BB}"/>
              </a:ext>
            </a:extLst>
          </p:cNvPr>
          <p:cNvCxnSpPr>
            <a:cxnSpLocks/>
          </p:cNvCxnSpPr>
          <p:nvPr/>
        </p:nvCxnSpPr>
        <p:spPr>
          <a:xfrm>
            <a:off x="8424433" y="1323855"/>
            <a:ext cx="6089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线连接符 87">
            <a:extLst>
              <a:ext uri="{FF2B5EF4-FFF2-40B4-BE49-F238E27FC236}">
                <a16:creationId xmlns:a16="http://schemas.microsoft.com/office/drawing/2014/main" id="{16796937-3DD2-819D-FA73-C6E0ED9D2D28}"/>
              </a:ext>
            </a:extLst>
          </p:cNvPr>
          <p:cNvCxnSpPr>
            <a:cxnSpLocks/>
          </p:cNvCxnSpPr>
          <p:nvPr/>
        </p:nvCxnSpPr>
        <p:spPr>
          <a:xfrm>
            <a:off x="8417125" y="5468163"/>
            <a:ext cx="6089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3E52C485-2AD0-AA37-7889-C13345362B24}"/>
              </a:ext>
            </a:extLst>
          </p:cNvPr>
          <p:cNvSpPr txBox="1"/>
          <p:nvPr/>
        </p:nvSpPr>
        <p:spPr>
          <a:xfrm>
            <a:off x="877930" y="329859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p</a:t>
            </a:r>
            <a:r>
              <a:rPr kumimoji="1"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</a:t>
            </a:r>
            <a:endParaRPr kumimoji="1"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2D88B40-8023-25BA-9259-E1678C449DCC}"/>
              </a:ext>
            </a:extLst>
          </p:cNvPr>
          <p:cNvSpPr txBox="1"/>
          <p:nvPr/>
        </p:nvSpPr>
        <p:spPr>
          <a:xfrm>
            <a:off x="5853848" y="362829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p</a:t>
            </a:r>
            <a:r>
              <a:rPr kumimoji="1"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endParaRPr kumimoji="1"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86849AC3-F9F0-5234-3CFB-511C0427ECE4}"/>
              </a:ext>
            </a:extLst>
          </p:cNvPr>
          <p:cNvSpPr txBox="1"/>
          <p:nvPr/>
        </p:nvSpPr>
        <p:spPr>
          <a:xfrm>
            <a:off x="6547203" y="362806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p</a:t>
            </a:r>
            <a:r>
              <a:rPr kumimoji="1"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</a:t>
            </a:r>
            <a:endParaRPr kumimoji="1"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856ED473-942C-FC0C-CF28-1A7235487C08}"/>
              </a:ext>
            </a:extLst>
          </p:cNvPr>
          <p:cNvSpPr txBox="1"/>
          <p:nvPr/>
        </p:nvSpPr>
        <p:spPr>
          <a:xfrm>
            <a:off x="6187550" y="4512684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p</a:t>
            </a:r>
            <a:r>
              <a:rPr kumimoji="1"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endParaRPr kumimoji="1"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CD029A7E-AE77-823F-5532-333AA90AE659}"/>
              </a:ext>
            </a:extLst>
          </p:cNvPr>
          <p:cNvSpPr txBox="1"/>
          <p:nvPr/>
        </p:nvSpPr>
        <p:spPr>
          <a:xfrm>
            <a:off x="7491882" y="512268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bp</a:t>
            </a:r>
            <a:r>
              <a:rPr kumimoji="1"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endParaRPr kumimoji="1"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91651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28585" y="606829"/>
            <a:ext cx="8516156" cy="6047976"/>
            <a:chOff x="12701" y="349137"/>
            <a:chExt cx="9131300" cy="619760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8D6DA534-56DB-7D86-D83C-168536DF05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1"/>
            <a:stretch/>
          </p:blipFill>
          <p:spPr>
            <a:xfrm>
              <a:off x="12701" y="349137"/>
              <a:ext cx="9131300" cy="6197600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A476D356-3C43-90D6-4743-79EEC56B48CB}"/>
                </a:ext>
              </a:extLst>
            </p:cNvPr>
            <p:cNvSpPr/>
            <p:nvPr/>
          </p:nvSpPr>
          <p:spPr>
            <a:xfrm>
              <a:off x="455806" y="394578"/>
              <a:ext cx="152028" cy="1516785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2DDA5C5-9F73-2A6E-81FC-520B605AEF61}"/>
                </a:ext>
              </a:extLst>
            </p:cNvPr>
            <p:cNvSpPr/>
            <p:nvPr/>
          </p:nvSpPr>
          <p:spPr>
            <a:xfrm>
              <a:off x="4149259" y="394577"/>
              <a:ext cx="152028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F05041E-DD83-4464-34D1-9B8E3E939F20}"/>
                </a:ext>
              </a:extLst>
            </p:cNvPr>
            <p:cNvSpPr/>
            <p:nvPr/>
          </p:nvSpPr>
          <p:spPr>
            <a:xfrm>
              <a:off x="7434537" y="394577"/>
              <a:ext cx="206289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9A2E5350-52AD-1F23-41AE-2C81CF98AC0C}"/>
                </a:ext>
              </a:extLst>
            </p:cNvPr>
            <p:cNvSpPr/>
            <p:nvPr/>
          </p:nvSpPr>
          <p:spPr>
            <a:xfrm>
              <a:off x="8247959" y="394575"/>
              <a:ext cx="97128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9BCC5D83-1ADA-B6A6-3A4E-5544304AEE5A}"/>
                </a:ext>
              </a:extLst>
            </p:cNvPr>
            <p:cNvSpPr/>
            <p:nvPr/>
          </p:nvSpPr>
          <p:spPr>
            <a:xfrm>
              <a:off x="8194382" y="3470657"/>
              <a:ext cx="68725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39E9F45E-882E-C2B5-D31C-3D5375386A10}"/>
                </a:ext>
              </a:extLst>
            </p:cNvPr>
            <p:cNvSpPr/>
            <p:nvPr/>
          </p:nvSpPr>
          <p:spPr>
            <a:xfrm>
              <a:off x="2996951" y="5017735"/>
              <a:ext cx="152028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338059" y="215325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64567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91193" y="369332"/>
            <a:ext cx="8844742" cy="4457416"/>
            <a:chOff x="0" y="1279421"/>
            <a:chExt cx="9144000" cy="462156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0A6B33EB-6F46-72BB-F651-1643F8F500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57308"/>
            <a:stretch/>
          </p:blipFill>
          <p:spPr>
            <a:xfrm>
              <a:off x="0" y="1283947"/>
              <a:ext cx="9144000" cy="4617035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B2E17A65-4627-D9D4-223E-BA726C32163D}"/>
                </a:ext>
              </a:extLst>
            </p:cNvPr>
            <p:cNvSpPr/>
            <p:nvPr/>
          </p:nvSpPr>
          <p:spPr>
            <a:xfrm>
              <a:off x="4179738" y="1286993"/>
              <a:ext cx="60959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5936AAFB-1CEB-42F6-445C-E9058B6CE367}"/>
                </a:ext>
              </a:extLst>
            </p:cNvPr>
            <p:cNvSpPr/>
            <p:nvPr/>
          </p:nvSpPr>
          <p:spPr>
            <a:xfrm>
              <a:off x="7783067" y="1279421"/>
              <a:ext cx="60959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8FDD1B66-C518-3860-A790-3970C915DE14}"/>
                </a:ext>
              </a:extLst>
            </p:cNvPr>
            <p:cNvSpPr/>
            <p:nvPr/>
          </p:nvSpPr>
          <p:spPr>
            <a:xfrm>
              <a:off x="5208614" y="1282467"/>
              <a:ext cx="60959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F46D5357-B5EA-9FED-3A68-1505E15F77A5}"/>
                </a:ext>
              </a:extLst>
            </p:cNvPr>
            <p:cNvSpPr/>
            <p:nvPr/>
          </p:nvSpPr>
          <p:spPr>
            <a:xfrm>
              <a:off x="5649418" y="4384196"/>
              <a:ext cx="152028" cy="1516785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1A7EA1A7-BB95-2231-7703-55A4110F87AB}"/>
                </a:ext>
              </a:extLst>
            </p:cNvPr>
            <p:cNvSpPr/>
            <p:nvPr/>
          </p:nvSpPr>
          <p:spPr>
            <a:xfrm>
              <a:off x="4047722" y="4384197"/>
              <a:ext cx="60959" cy="1516785"/>
            </a:xfrm>
            <a:prstGeom prst="rect">
              <a:avLst/>
            </a:prstGeom>
            <a:noFill/>
            <a:ln>
              <a:solidFill>
                <a:srgbClr val="FF26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2400"/>
            </a:p>
          </p:txBody>
        </p:sp>
      </p:grpSp>
      <p:sp>
        <p:nvSpPr>
          <p:cNvPr id="14" name="文本框 13"/>
          <p:cNvSpPr txBox="1"/>
          <p:nvPr/>
        </p:nvSpPr>
        <p:spPr>
          <a:xfrm>
            <a:off x="299221" y="0"/>
            <a:ext cx="109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2141303" y="1839548"/>
            <a:ext cx="5256000" cy="15242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4012487" y="2110154"/>
            <a:ext cx="243371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dirty="0"/>
              <a:t>intron</a:t>
            </a:r>
            <a:endParaRPr lang="zh-CN" altLang="en-US" sz="4400" dirty="0"/>
          </a:p>
        </p:txBody>
      </p:sp>
    </p:spTree>
    <p:extLst>
      <p:ext uri="{BB962C8B-B14F-4D97-AF65-F5344CB8AC3E}">
        <p14:creationId xmlns:p14="http://schemas.microsoft.com/office/powerpoint/2010/main" val="2089477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6</TotalTime>
  <Words>816</Words>
  <Application>Microsoft Office PowerPoint</Application>
  <PresentationFormat>全屏显示(4:3)</PresentationFormat>
  <Paragraphs>128</Paragraphs>
  <Slides>1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26" baseType="lpstr">
      <vt:lpstr>DengXian</vt:lpstr>
      <vt:lpstr>DengXian</vt:lpstr>
      <vt:lpstr>等线 Light</vt:lpstr>
      <vt:lpstr>SimHei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lin</dc:creator>
  <cp:lastModifiedBy>zlin</cp:lastModifiedBy>
  <cp:revision>64</cp:revision>
  <dcterms:created xsi:type="dcterms:W3CDTF">2025-01-03T07:31:58Z</dcterms:created>
  <dcterms:modified xsi:type="dcterms:W3CDTF">2025-04-07T02:17:56Z</dcterms:modified>
</cp:coreProperties>
</file>